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8229600" cy="82296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716" y="-108"/>
      </p:cViewPr>
      <p:guideLst>
        <p:guide orient="horz" pos="2592"/>
        <p:guide pos="259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17220" y="2556511"/>
            <a:ext cx="6995160" cy="176403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4440" y="4663440"/>
            <a:ext cx="5760720" cy="21031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264E-1E6A-45B8-B3C9-B6603C43E5D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7F8EA-5AB8-4D3F-8F27-912BD4914E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264E-1E6A-45B8-B3C9-B6603C43E5D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7F8EA-5AB8-4D3F-8F27-912BD4914E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70672" y="396240"/>
            <a:ext cx="1665923" cy="842581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0047" y="396240"/>
            <a:ext cx="4863465" cy="842581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264E-1E6A-45B8-B3C9-B6603C43E5D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7F8EA-5AB8-4D3F-8F27-912BD4914E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264E-1E6A-45B8-B3C9-B6603C43E5D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7F8EA-5AB8-4D3F-8F27-912BD4914E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0082" y="5288281"/>
            <a:ext cx="6995160" cy="163449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0082" y="3488056"/>
            <a:ext cx="6995160" cy="180022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264E-1E6A-45B8-B3C9-B6603C43E5D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7F8EA-5AB8-4D3F-8F27-912BD4914E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0047" y="2305050"/>
            <a:ext cx="3264693" cy="651700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1900" y="2305050"/>
            <a:ext cx="3264694" cy="651700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264E-1E6A-45B8-B3C9-B6603C43E5D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7F8EA-5AB8-4D3F-8F27-912BD4914E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1480" y="329566"/>
            <a:ext cx="7406640" cy="13716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1480" y="1842136"/>
            <a:ext cx="3636169" cy="7677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1480" y="2609850"/>
            <a:ext cx="3636169" cy="474154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80523" y="1842136"/>
            <a:ext cx="3637598" cy="7677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80523" y="2609850"/>
            <a:ext cx="3637598" cy="474154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264E-1E6A-45B8-B3C9-B6603C43E5D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7F8EA-5AB8-4D3F-8F27-912BD4914E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264E-1E6A-45B8-B3C9-B6603C43E5D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7F8EA-5AB8-4D3F-8F27-912BD4914E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264E-1E6A-45B8-B3C9-B6603C43E5D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7F8EA-5AB8-4D3F-8F27-912BD4914E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1480" y="327660"/>
            <a:ext cx="2707482" cy="139446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7545" y="327660"/>
            <a:ext cx="4600575" cy="702373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11480" y="1722120"/>
            <a:ext cx="2707482" cy="562927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264E-1E6A-45B8-B3C9-B6603C43E5D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7F8EA-5AB8-4D3F-8F27-912BD4914E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13059" y="5760720"/>
            <a:ext cx="4937760" cy="68008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613059" y="735330"/>
            <a:ext cx="4937760" cy="493776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13059" y="6440806"/>
            <a:ext cx="4937760" cy="96583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264E-1E6A-45B8-B3C9-B6603C43E5D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7F8EA-5AB8-4D3F-8F27-912BD4914E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11480" y="329566"/>
            <a:ext cx="7406640" cy="1371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1480" y="1920240"/>
            <a:ext cx="7406640" cy="54311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11480" y="7627621"/>
            <a:ext cx="192024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0264E-1E6A-45B8-B3C9-B6603C43E5D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11780" y="7627621"/>
            <a:ext cx="260604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97880" y="7627621"/>
            <a:ext cx="192024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77F8EA-5AB8-4D3F-8F27-912BD4914EA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jpeg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tiff"/><Relationship Id="rId10" Type="http://schemas.openxmlformats.org/officeDocument/2006/relationships/image" Target="../media/image9.jpe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/>
          <p:cNvGrpSpPr>
            <a:grpSpLocks noChangeAspect="1"/>
          </p:cNvGrpSpPr>
          <p:nvPr/>
        </p:nvGrpSpPr>
        <p:grpSpPr>
          <a:xfrm>
            <a:off x="761422" y="226288"/>
            <a:ext cx="6553778" cy="7086679"/>
            <a:chOff x="761422" y="226288"/>
            <a:chExt cx="6553778" cy="7086679"/>
          </a:xfrm>
        </p:grpSpPr>
        <p:grpSp>
          <p:nvGrpSpPr>
            <p:cNvPr id="4" name="Group 3"/>
            <p:cNvGrpSpPr/>
            <p:nvPr/>
          </p:nvGrpSpPr>
          <p:grpSpPr>
            <a:xfrm>
              <a:off x="761422" y="226288"/>
              <a:ext cx="6401378" cy="5918204"/>
              <a:chOff x="152400" y="226288"/>
              <a:chExt cx="6401378" cy="5918204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1246908" y="226288"/>
                <a:ext cx="685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Helvetica" pitchFamily="34" charset="0"/>
                    <a:cs typeface="Helvetica" pitchFamily="34" charset="0"/>
                  </a:rPr>
                  <a:t>DVC</a:t>
                </a:r>
                <a:endParaRPr lang="en-US" sz="1200" dirty="0">
                  <a:latin typeface="Helvetica" pitchFamily="34" charset="0"/>
                  <a:cs typeface="Helvetica" pitchFamily="34" charset="0"/>
                </a:endParaRPr>
              </a:p>
            </p:txBody>
          </p:sp>
          <p:pic>
            <p:nvPicPr>
              <p:cNvPr id="6" name="Picture 2" descr="C:\Users\dell\Desktop\Manuscript 050314\12 days lignin\DVI12_1.jpg"/>
              <p:cNvPicPr preferRelativeResize="0">
                <a:picLocks noChangeArrowheads="1"/>
              </p:cNvPicPr>
              <p:nvPr/>
            </p:nvPicPr>
            <p:blipFill>
              <a:blip r:embed="rId2" cstate="print"/>
              <a:srcRect l="45867" t="29659" r="26242" b="36872"/>
              <a:stretch>
                <a:fillRect/>
              </a:stretch>
            </p:blipFill>
            <p:spPr bwMode="auto">
              <a:xfrm>
                <a:off x="914400" y="3343564"/>
                <a:ext cx="1371600" cy="1371600"/>
              </a:xfrm>
              <a:prstGeom prst="rect">
                <a:avLst/>
              </a:prstGeom>
              <a:noFill/>
            </p:spPr>
          </p:pic>
          <p:pic>
            <p:nvPicPr>
              <p:cNvPr id="7" name="Picture 2"/>
              <p:cNvPicPr preferRelativeResize="0">
                <a:picLocks noChangeArrowheads="1"/>
              </p:cNvPicPr>
              <p:nvPr/>
            </p:nvPicPr>
            <p:blipFill>
              <a:blip r:embed="rId3" cstate="print"/>
              <a:srcRect l="8571" t="7619" r="28571" b="12381"/>
              <a:stretch>
                <a:fillRect/>
              </a:stretch>
            </p:blipFill>
            <p:spPr bwMode="auto">
              <a:xfrm>
                <a:off x="914400" y="4761344"/>
                <a:ext cx="1371600" cy="1371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8" name="Picture 2"/>
              <p:cNvPicPr preferRelativeResize="0">
                <a:picLocks noChangeArrowheads="1"/>
              </p:cNvPicPr>
              <p:nvPr/>
            </p:nvPicPr>
            <p:blipFill>
              <a:blip r:embed="rId4" cstate="print"/>
              <a:srcRect l="11538" t="3846" r="25000" b="15385"/>
              <a:stretch>
                <a:fillRect/>
              </a:stretch>
            </p:blipFill>
            <p:spPr bwMode="auto">
              <a:xfrm>
                <a:off x="2325256" y="542636"/>
                <a:ext cx="1371600" cy="1371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9" name="Picture 2"/>
              <p:cNvPicPr preferRelativeResize="0">
                <a:picLocks noChangeArrowheads="1"/>
              </p:cNvPicPr>
              <p:nvPr/>
            </p:nvPicPr>
            <p:blipFill>
              <a:blip r:embed="rId5" cstate="print"/>
              <a:srcRect l="17308" t="7692" r="36538" b="30769"/>
              <a:stretch>
                <a:fillRect/>
              </a:stretch>
            </p:blipFill>
            <p:spPr bwMode="auto">
              <a:xfrm>
                <a:off x="2334492" y="1953492"/>
                <a:ext cx="1371600" cy="1371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0" name="Picture 2" descr="C:\Users\dell\Desktop\Manuscript 050314\12 days lignin\DVC12_1.jpg"/>
              <p:cNvPicPr preferRelativeResize="0">
                <a:picLocks noChangeArrowheads="1"/>
              </p:cNvPicPr>
              <p:nvPr/>
            </p:nvPicPr>
            <p:blipFill>
              <a:blip r:embed="rId6" cstate="print"/>
              <a:srcRect l="45381" t="38515" r="34330" b="34385"/>
              <a:stretch>
                <a:fillRect/>
              </a:stretch>
            </p:blipFill>
            <p:spPr bwMode="auto">
              <a:xfrm>
                <a:off x="2334492" y="3352800"/>
                <a:ext cx="1371600" cy="1371600"/>
              </a:xfrm>
              <a:prstGeom prst="rect">
                <a:avLst/>
              </a:prstGeom>
              <a:noFill/>
            </p:spPr>
          </p:pic>
          <p:pic>
            <p:nvPicPr>
              <p:cNvPr id="11" name="Picture 2"/>
              <p:cNvPicPr preferRelativeResize="0">
                <a:picLocks noChangeArrowheads="1"/>
              </p:cNvPicPr>
              <p:nvPr/>
            </p:nvPicPr>
            <p:blipFill>
              <a:blip r:embed="rId7" cstate="print"/>
              <a:srcRect l="10811" t="7207" r="18919" b="13514"/>
              <a:stretch>
                <a:fillRect/>
              </a:stretch>
            </p:blipFill>
            <p:spPr bwMode="auto">
              <a:xfrm rot="16200000">
                <a:off x="2343728" y="4772892"/>
                <a:ext cx="1371600" cy="1371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2" name="Picture 2"/>
              <p:cNvPicPr preferRelativeResize="0">
                <a:picLocks noChangeArrowheads="1"/>
              </p:cNvPicPr>
              <p:nvPr/>
            </p:nvPicPr>
            <p:blipFill>
              <a:blip r:embed="rId8" cstate="print"/>
              <a:srcRect l="22223" r="16662" b="18519"/>
              <a:stretch>
                <a:fillRect/>
              </a:stretch>
            </p:blipFill>
            <p:spPr bwMode="auto">
              <a:xfrm>
                <a:off x="3743036" y="1944256"/>
                <a:ext cx="1371600" cy="1371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3" name="Picture 2"/>
              <p:cNvPicPr preferRelativeResize="0">
                <a:picLocks noChangeArrowheads="1"/>
              </p:cNvPicPr>
              <p:nvPr/>
            </p:nvPicPr>
            <p:blipFill>
              <a:blip r:embed="rId9" cstate="print"/>
              <a:srcRect l="27500" t="26667" r="46250" b="40000"/>
              <a:stretch>
                <a:fillRect/>
              </a:stretch>
            </p:blipFill>
            <p:spPr bwMode="auto">
              <a:xfrm>
                <a:off x="3743036" y="3352800"/>
                <a:ext cx="1371600" cy="1371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4" name="Picture 13" descr="C:\Users\dell\Desktop\Manuscript 050314\12 days lignin\JGC12_1.jpg"/>
              <p:cNvPicPr preferRelativeResize="0">
                <a:picLocks noChangeArrowheads="1"/>
              </p:cNvPicPr>
              <p:nvPr/>
            </p:nvPicPr>
            <p:blipFill>
              <a:blip r:embed="rId10" cstate="print"/>
              <a:srcRect l="35913" t="32096" r="32282" b="28878"/>
              <a:stretch>
                <a:fillRect/>
              </a:stretch>
            </p:blipFill>
            <p:spPr bwMode="auto">
              <a:xfrm>
                <a:off x="3752272" y="4763656"/>
                <a:ext cx="1371600" cy="1371600"/>
              </a:xfrm>
              <a:prstGeom prst="rect">
                <a:avLst/>
              </a:prstGeom>
              <a:noFill/>
            </p:spPr>
          </p:pic>
          <p:pic>
            <p:nvPicPr>
              <p:cNvPr id="15" name="Picture 2"/>
              <p:cNvPicPr preferRelativeResize="0">
                <a:picLocks noChangeArrowheads="1"/>
              </p:cNvPicPr>
              <p:nvPr/>
            </p:nvPicPr>
            <p:blipFill>
              <a:blip r:embed="rId11" cstate="print"/>
              <a:srcRect l="44896" t="23889" r="23021" b="34861"/>
              <a:stretch>
                <a:fillRect/>
              </a:stretch>
            </p:blipFill>
            <p:spPr bwMode="auto">
              <a:xfrm>
                <a:off x="5181600" y="1944256"/>
                <a:ext cx="1371600" cy="1371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6" name="Picture 3"/>
              <p:cNvPicPr preferRelativeResize="0">
                <a:picLocks noChangeArrowheads="1"/>
              </p:cNvPicPr>
              <p:nvPr/>
            </p:nvPicPr>
            <p:blipFill>
              <a:blip r:embed="rId12" cstate="print"/>
              <a:srcRect l="28000" t="14000" r="30000" b="35333"/>
              <a:stretch>
                <a:fillRect/>
              </a:stretch>
            </p:blipFill>
            <p:spPr bwMode="auto">
              <a:xfrm rot="5400000">
                <a:off x="5181600" y="3352800"/>
                <a:ext cx="1371600" cy="1371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7" name="Picture 2" descr="C:\Users\dell\Desktop\Manuscript 050314\12 days lignin\JGI12_2STAINED.jpg"/>
              <p:cNvPicPr preferRelativeResize="0">
                <a:picLocks noChangeArrowheads="1"/>
              </p:cNvPicPr>
              <p:nvPr/>
            </p:nvPicPr>
            <p:blipFill>
              <a:blip r:embed="rId13" cstate="print"/>
              <a:srcRect l="31250" t="36111" r="37500" b="22222"/>
              <a:stretch>
                <a:fillRect/>
              </a:stretch>
            </p:blipFill>
            <p:spPr bwMode="auto">
              <a:xfrm>
                <a:off x="5181600" y="4763656"/>
                <a:ext cx="1371600" cy="1371600"/>
              </a:xfrm>
              <a:prstGeom prst="rect">
                <a:avLst/>
              </a:prstGeom>
              <a:noFill/>
            </p:spPr>
          </p:pic>
          <p:sp>
            <p:nvSpPr>
              <p:cNvPr id="18" name="TextBox 17"/>
              <p:cNvSpPr txBox="1"/>
              <p:nvPr/>
            </p:nvSpPr>
            <p:spPr>
              <a:xfrm>
                <a:off x="228600" y="1027544"/>
                <a:ext cx="685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Helvetica" pitchFamily="34" charset="0"/>
                    <a:cs typeface="Helvetica" pitchFamily="34" charset="0"/>
                  </a:rPr>
                  <a:t>2 DAI</a:t>
                </a:r>
                <a:endParaRPr lang="en-US" sz="12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152400" y="5248564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Helvetica" pitchFamily="34" charset="0"/>
                    <a:cs typeface="Helvetica" pitchFamily="34" charset="0"/>
                  </a:rPr>
                  <a:t>12 DAI </a:t>
                </a:r>
                <a:endParaRPr lang="en-US" sz="12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2676236" y="228600"/>
                <a:ext cx="685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Helvetica" pitchFamily="34" charset="0"/>
                    <a:cs typeface="Helvetica" pitchFamily="34" charset="0"/>
                  </a:rPr>
                  <a:t>DVI</a:t>
                </a:r>
                <a:endParaRPr lang="en-US" sz="12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4114800" y="228600"/>
                <a:ext cx="685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Helvetica" pitchFamily="34" charset="0"/>
                    <a:cs typeface="Helvetica" pitchFamily="34" charset="0"/>
                  </a:rPr>
                  <a:t>JGC</a:t>
                </a:r>
                <a:endParaRPr lang="en-US" sz="12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5514108" y="228600"/>
                <a:ext cx="685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Helvetica" pitchFamily="34" charset="0"/>
                    <a:cs typeface="Helvetica" pitchFamily="34" charset="0"/>
                  </a:rPr>
                  <a:t>JGI</a:t>
                </a:r>
                <a:endParaRPr lang="en-US" sz="1200" dirty="0">
                  <a:latin typeface="Helvetica" pitchFamily="34" charset="0"/>
                  <a:cs typeface="Helvetica" pitchFamily="34" charset="0"/>
                </a:endParaRPr>
              </a:p>
            </p:txBody>
          </p:sp>
          <p:pic>
            <p:nvPicPr>
              <p:cNvPr id="23" name="Picture 2" descr="C:\Users\y.kumar\Desktop\lig.tif"/>
              <p:cNvPicPr>
                <a:picLocks noChangeAspect="1" noChangeArrowheads="1"/>
              </p:cNvPicPr>
              <p:nvPr/>
            </p:nvPicPr>
            <p:blipFill>
              <a:blip r:embed="rId14" cstate="print"/>
              <a:srcRect/>
              <a:stretch>
                <a:fillRect/>
              </a:stretch>
            </p:blipFill>
            <p:spPr bwMode="auto">
              <a:xfrm>
                <a:off x="5163128" y="533400"/>
                <a:ext cx="1390650" cy="1390650"/>
              </a:xfrm>
              <a:prstGeom prst="rect">
                <a:avLst/>
              </a:prstGeom>
              <a:noFill/>
            </p:spPr>
          </p:pic>
          <p:pic>
            <p:nvPicPr>
              <p:cNvPr id="24" name="Picture 3" descr="C:\Users\y.kumar\Desktop\lig.tif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/>
              <a:stretch>
                <a:fillRect/>
              </a:stretch>
            </p:blipFill>
            <p:spPr bwMode="auto">
              <a:xfrm>
                <a:off x="3733800" y="533400"/>
                <a:ext cx="1390650" cy="1390650"/>
              </a:xfrm>
              <a:prstGeom prst="rect">
                <a:avLst/>
              </a:prstGeom>
              <a:noFill/>
            </p:spPr>
          </p:pic>
          <p:sp>
            <p:nvSpPr>
              <p:cNvPr id="25" name="TextBox 24"/>
              <p:cNvSpPr txBox="1"/>
              <p:nvPr/>
            </p:nvSpPr>
            <p:spPr>
              <a:xfrm>
                <a:off x="228600" y="2438400"/>
                <a:ext cx="685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Helvetica" pitchFamily="34" charset="0"/>
                    <a:cs typeface="Helvetica" pitchFamily="34" charset="0"/>
                  </a:rPr>
                  <a:t>4 DAI</a:t>
                </a:r>
                <a:endParaRPr lang="en-US" sz="12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228600" y="3837708"/>
                <a:ext cx="762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Helvetica" pitchFamily="34" charset="0"/>
                    <a:cs typeface="Helvetica" pitchFamily="34" charset="0"/>
                  </a:rPr>
                  <a:t>8 DAI</a:t>
                </a:r>
                <a:endParaRPr lang="en-US" sz="1200" dirty="0">
                  <a:latin typeface="Helvetica" pitchFamily="34" charset="0"/>
                  <a:cs typeface="Helvetica" pitchFamily="34" charset="0"/>
                </a:endParaRPr>
              </a:p>
            </p:txBody>
          </p:sp>
          <p:pic>
            <p:nvPicPr>
              <p:cNvPr id="27" name="Picture 4" descr="C:\Users\y.kumar\Desktop\lig.tif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 bwMode="auto">
              <a:xfrm>
                <a:off x="895928" y="533400"/>
                <a:ext cx="1390650" cy="1390650"/>
              </a:xfrm>
              <a:prstGeom prst="rect">
                <a:avLst/>
              </a:prstGeom>
              <a:noFill/>
            </p:spPr>
          </p:pic>
          <p:pic>
            <p:nvPicPr>
              <p:cNvPr id="28" name="Picture 27"/>
              <p:cNvPicPr preferRelativeResize="0">
                <a:picLocks noChangeArrowheads="1"/>
              </p:cNvPicPr>
              <p:nvPr/>
            </p:nvPicPr>
            <p:blipFill>
              <a:blip r:embed="rId17" cstate="print"/>
              <a:srcRect l="39375" t="34166" r="38125" b="32500"/>
              <a:stretch>
                <a:fillRect/>
              </a:stretch>
            </p:blipFill>
            <p:spPr bwMode="auto">
              <a:xfrm rot="16200000">
                <a:off x="914400" y="1944256"/>
                <a:ext cx="1371600" cy="1371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29" name="Rectangle 28"/>
            <p:cNvSpPr/>
            <p:nvPr/>
          </p:nvSpPr>
          <p:spPr>
            <a:xfrm>
              <a:off x="838200" y="6666636"/>
              <a:ext cx="6477000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 smtClean="0">
                  <a:latin typeface="Helvetica" pitchFamily="34" charset="0"/>
                  <a:cs typeface="Helvetica" pitchFamily="34" charset="0"/>
                </a:rPr>
                <a:t>Figure </a:t>
              </a:r>
              <a:r>
                <a:rPr lang="en-US" sz="1200" b="1" dirty="0" smtClean="0">
                  <a:latin typeface="Helvetica" pitchFamily="34" charset="0"/>
                  <a:cs typeface="Helvetica" pitchFamily="34" charset="0"/>
                </a:rPr>
                <a:t>S3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: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Pattern of lignification in cross sections of chickpea root tissue from resistant-DV and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susceptible-JG62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at different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Foc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inoculation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stages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using phloroglucinol/ hydrochloric acid stain.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1</Words>
  <Application>Microsoft Office PowerPoint</Application>
  <PresentationFormat>Custom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Yashwant Kumar</dc:creator>
  <cp:lastModifiedBy>Bhushan</cp:lastModifiedBy>
  <cp:revision>5</cp:revision>
  <dcterms:created xsi:type="dcterms:W3CDTF">2014-05-21T13:30:05Z</dcterms:created>
  <dcterms:modified xsi:type="dcterms:W3CDTF">2015-09-22T14:57:15Z</dcterms:modified>
</cp:coreProperties>
</file>